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LB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238"/>
  </p:normalViewPr>
  <p:slideViewPr>
    <p:cSldViewPr snapToGrid="0" snapToObjects="1">
      <p:cViewPr varScale="1">
        <p:scale>
          <a:sx n="96" d="100"/>
          <a:sy n="96" d="100"/>
        </p:scale>
        <p:origin x="62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A41F48-766B-A549-B5ED-68F3D0FF3F3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EFD25C8-7860-B244-B554-730B2990E83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L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AD880D-91E3-684B-8D95-E9BB8432AB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E1AA0D-0987-AA46-9813-AE87C2610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12BD5B-1E7B-7440-8F5D-F99B633C08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41951581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97CA6F-4ECB-F642-A725-12C3DFC07C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73B2C3-3895-7C47-B51D-111F83CD99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C4BCFB-429F-C742-9D3E-73C03EF480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33ADE2-DF3F-F141-8FC0-9C7036F878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682E0C-C4DA-014E-9194-1EC1E5FE67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12954664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C4C2D71-DDCF-B54C-8E11-A28768295BE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E6C760-38B7-6644-A204-8AA7B3F64A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40AFF5-38D8-CD44-BB1E-18AF8DA6AB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BA9DBE-7643-8D42-898F-3A9D6D3F9F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485111-7727-BB4F-BD5A-5F445AEA4B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444404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F18A01-4417-9D4D-8BED-D6FCE42A5B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B41321-22F7-C642-A7E2-FFB875265E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F6DBDF-6265-AD4C-87C5-D2E41D5CFD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9882DC-3E7D-CB4C-9DDD-DACED1A361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386ADF-C4A0-5040-AE84-2B13506903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2251723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E82155-7514-6F4C-AF3D-78ED8F52DB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7696B3-1536-C04A-B09D-455799BFD9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231068-E331-1844-B3BB-8CFAD799C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4068B0-C177-BC4A-AF91-80BD65042E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04CA4F-2F1B-4545-BB18-8D884F291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33435612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EE3E26-5C39-B14F-9FE3-CE5442FC05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4AC16D-6968-9147-93B7-4AB44625D2D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BE1470C-A9C9-8A40-B193-B84ACCBC4B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C0BF4A-AB97-D64B-8D3C-296FFFE53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13762A-51B6-D349-B12A-95ECF3722B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FE14C2-FD2D-C54A-9778-8359AE53AB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192662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A53128-73E1-9546-9A5F-D69D2D58B7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1663EF-9248-C74C-90F1-F357F8864E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2AFB939-7209-A64D-A856-7702E1B67E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1FDBB1F-553F-BA44-9302-139C3B9BE8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A5B6ACE-C3FE-FA4D-89A0-77A12198538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89A0371-B358-814F-A5C7-48CB15D3DE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C189CED-4E65-BD47-9B21-680B60806B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E932ADD-9A15-7546-BDA3-0221B7AB47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1517864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EA5BDD-CF9E-0045-B7A1-5666ED7B0F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6B85487-1E3F-F04D-BD2B-9A5F6EDB55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F59ED9-B7F9-B647-8323-AB13966F23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3B30089-03BF-2F44-9387-24DEDC341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16420397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E92AC31-1D05-DB48-8AD1-B60B161B2E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ECD4F23-37E7-8E4A-B682-8A7DA09C70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5FF0132-DAB5-074C-95D1-169BCF4BCF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24167237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C12A0D-335F-C04F-B302-D90C8426EF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00CA70-0E45-6340-8C34-5E2AEAB0BB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22E810-67F5-EB41-BA42-36B612C1B2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6047B9-5C5F-334F-8F61-FFA70947D1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D15019-05EC-A149-8B62-23F00643F3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77DE63-049F-964D-BDC4-2D67D08AE4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33468310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48BCB8-63C1-E14D-892F-50EE0F778A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DBFDB91-6746-6E46-8E24-A210DA35D3D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L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9218F66-EB40-CA44-8F8B-216F552CDE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A2EE5D-EE53-A348-AADB-46DE284750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BAB4EB-5471-E048-958B-353B037C50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A90300-B56C-0A41-9D81-118194B1E9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2424986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954E60E-37D6-9847-B9E2-522EB11E3F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6484F2-BC99-914D-9F3F-FA7125A107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4BDA04-0980-334A-A264-609ADD8D39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8DC1DC-D237-7242-88E0-B58C88BC81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L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DCAE20-E66F-FF45-B7E4-F9045B07F29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3900339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LB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cran.r-project.org/package=leafletR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Map&#10;&#10;Description automatically generated">
            <a:extLst>
              <a:ext uri="{FF2B5EF4-FFF2-40B4-BE49-F238E27FC236}">
                <a16:creationId xmlns:a16="http://schemas.microsoft.com/office/drawing/2014/main" id="{EB925AEA-ED00-D74B-8E0C-804E111CE8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1015" y="148055"/>
            <a:ext cx="7762221" cy="45098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A75F783-B40A-4948-ADE6-C3A9668F5FCF}"/>
              </a:ext>
            </a:extLst>
          </p:cNvPr>
          <p:cNvSpPr txBox="1"/>
          <p:nvPr/>
        </p:nvSpPr>
        <p:spPr>
          <a:xfrm>
            <a:off x="2568983" y="4825404"/>
            <a:ext cx="9623017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LB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LB" sz="11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GB" sz="1100" dirty="0"/>
              <a:t>Map of the Czech Republic (created using the Leaflet package v.0.4-0 [</a:t>
            </a:r>
            <a:r>
              <a:rPr lang="en-GB" sz="1100" u="sng" dirty="0">
                <a:hlinkClick r:id="rId3"/>
              </a:rPr>
              <a:t>http://cran.r-project.org/package=leafletR</a:t>
            </a:r>
            <a:r>
              <a:rPr lang="en-LB" sz="1100" dirty="0"/>
              <a:t>]</a:t>
            </a:r>
            <a:r>
              <a:rPr lang="en-GB" sz="1100" dirty="0"/>
              <a:t> in R-studio v.1.4.1717 [http://</a:t>
            </a:r>
            <a:r>
              <a:rPr lang="en-GB" sz="1100" dirty="0" err="1"/>
              <a:t>www.rstudio.com</a:t>
            </a:r>
            <a:r>
              <a:rPr lang="en-GB" sz="1100" dirty="0"/>
              <a:t>/] from R-project v.3.0.1 [https://</a:t>
            </a:r>
            <a:r>
              <a:rPr lang="en-GB" sz="1100" dirty="0" err="1"/>
              <a:t>www.R-project.org</a:t>
            </a:r>
            <a:r>
              <a:rPr lang="en-GB" sz="1100"/>
              <a:t>/]). </a:t>
            </a:r>
            <a:r>
              <a:rPr lang="en-GB" sz="1100" dirty="0"/>
              <a:t>The map shows the</a:t>
            </a:r>
            <a:r>
              <a:rPr lang="en-LB" sz="1100" dirty="0"/>
              <a:t> </a:t>
            </a:r>
            <a:r>
              <a:rPr lang="en-LB" sz="1100" dirty="0">
                <a:latin typeface="Arial" panose="020B0604020202020204" pitchFamily="34" charset="0"/>
                <a:cs typeface="Arial" panose="020B0604020202020204" pitchFamily="34" charset="0"/>
              </a:rPr>
              <a:t>number of KPC positive cases studied (108)  across the different geographic locations in the Czech Republic.</a:t>
            </a:r>
          </a:p>
        </p:txBody>
      </p:sp>
    </p:spTree>
    <p:extLst>
      <p:ext uri="{BB962C8B-B14F-4D97-AF65-F5344CB8AC3E}">
        <p14:creationId xmlns:p14="http://schemas.microsoft.com/office/powerpoint/2010/main" val="42460811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81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brahim bitar</dc:creator>
  <cp:lastModifiedBy>ibrahim bitar</cp:lastModifiedBy>
  <cp:revision>5</cp:revision>
  <dcterms:created xsi:type="dcterms:W3CDTF">2021-04-12T11:50:41Z</dcterms:created>
  <dcterms:modified xsi:type="dcterms:W3CDTF">2021-07-22T16:46:38Z</dcterms:modified>
</cp:coreProperties>
</file>